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5" r:id="rId2"/>
    <p:sldId id="266" r:id="rId3"/>
    <p:sldId id="26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0000"/>
  </p:normalViewPr>
  <p:slideViewPr>
    <p:cSldViewPr snapToGrid="0">
      <p:cViewPr varScale="1">
        <p:scale>
          <a:sx n="114" d="100"/>
          <a:sy n="114" d="100"/>
        </p:scale>
        <p:origin x="57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192FCE-B044-CF44-95A0-88356D011018}" type="datetimeFigureOut">
              <a:rPr lang="en-US" smtClean="0"/>
              <a:t>7/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6859C5-A2A2-E04F-B345-387DB2A39BC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539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C0F2052-97BF-B24E-A719-4467A9121F7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92619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C0F2052-97BF-B24E-A719-4467A9121F7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7235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3D1A7-8B33-2A9C-3D79-2D8CA5585BA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80A1BEC-8D42-DD58-6B21-FE5BE5ED82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B85B64-13E5-FC73-8CE0-BA6B2F94E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446F76-F51B-C761-AF57-8EF31A675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14D741-6FF7-90E7-F768-280CAF946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896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5A75FA-CAEE-D75A-BAAF-C6E65F2E64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F4055B-2F6F-E0FA-B1D0-AF81383308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D9E1F5-914C-8ED7-95DF-0D6C08C23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726D88-1D03-9BC3-D248-A4659EAFE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E8B359-425E-8152-42CC-632AEA9CC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2135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6B629E-9F22-C809-283A-451EB6B08C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71975D-2D40-AEDE-E2DC-EB92B587A8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C72ACC-0A8C-EF01-4186-D639257BA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8A1C44-20FB-4703-6858-1941698F7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445E9C-CCDF-9903-0F5E-B14C94A54C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466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7F5990-0107-A0FF-5367-4DFCB9932E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53629E-8FF8-05C4-EFFF-AF14723254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A36B90-F159-0FD5-278A-5330BFC23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572EB7-23A4-7020-28B7-9DE84BC78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8C029A-D067-C1A4-1D75-9520A2E00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224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8533D7-06AD-F6BC-D2FE-F58AFB06A1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F3A8E7-2665-288A-658B-6D5DB1B5FD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80571B-D2A2-BB9E-A670-2145182FC3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EBE870-8E3D-F72F-5132-37A71BF486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BCA445-7F5D-FE0F-B171-02D3549300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530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7A843D-F6D6-C6BD-09F6-263E6B7C01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A3ACCE-5729-5321-370E-CFB1965225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9CCFD7-B5D5-1DBC-2E21-B3954D476E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3EB108-18E1-95F1-4294-D480CEA01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207551-D9C7-09AB-50C8-C2201EF6B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E6AAD4-5F7C-531A-97AA-6B21A31E2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146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5B0AD-D30D-AB8C-C998-7868DC5E1B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A7D5E1-BC31-1841-B4B5-2EA6A90648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856AA5-0303-674F-8394-9B3CFCF3B7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3D93B5-220C-0E80-C13B-990A66DE6B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7D25F5-3CB0-1FC2-0F48-947AC62E2E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8DEEC5-0475-C38A-EDF6-0FBE5852E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91A1346-A7F2-65C5-7012-15457D8A5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EF87335-A646-B213-1C10-1C98A9B953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616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236D62-2F92-7C47-A682-5DD3FF09AA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F44F52-DDB7-9A97-2CD7-7AEA8B0E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69C29F9-C396-0EF2-A613-986A87365D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756CFD-3016-E9A2-6674-4E5ABD61F3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607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D064A98-4F84-0EF5-438E-6011F989B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E688B85-CE20-15C9-888C-C03130E7E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4A0964-1865-AA71-D53A-F5559FE52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5484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E3EAC3-70B2-795F-A5B5-F019BB298C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C90194-456A-1377-364B-6B87C73EB2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C0F954-9B7B-9A5B-3CEF-005AD1635C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D27A72-B049-163B-4636-0C93895D0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B3A693-39DC-485F-899E-4125022EE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EF0EA4-C4AE-BF39-E913-50F53C1F8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333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FFDB27-F929-705B-193B-085DF717FF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F34819E-0C79-2193-75A4-BE774C3495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107EB6-73C7-8B94-7F00-B69071606A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7E8051-FA1E-FC29-8974-E3EBDFB5C9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1DBF45-353E-B306-1AD0-95D4A4E17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4AB019-9AAD-5DB4-CE51-D5E0BBB21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452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21A9CC2-5697-6C98-BA4E-D15CFBEA03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5FBF7C-91BA-9E64-8C01-5C7B4D621F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1081D5-4F36-F5A5-2310-69C2684B75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C5F7857-0B30-3F47-BBDF-AB4851F555BF}" type="datetimeFigureOut">
              <a:rPr lang="en-US" smtClean="0"/>
              <a:t>7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2050F4-33D5-CE82-FD97-3FA0EBBAA9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954360-1CEE-ADBB-F6F0-B9E3C0941F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1FD3A9-D5FB-014D-8531-851498605E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411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81EEA11-046D-8EE1-6ACF-6CE27F64A0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1811" y="314496"/>
            <a:ext cx="11064806" cy="62239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84549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A006AA8-4F87-EC58-70B6-9DBE6CDC66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29012"/>
            <a:ext cx="11582400" cy="65151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ED04D73-440B-C534-E2BD-ADDC64AED3DC}"/>
              </a:ext>
            </a:extLst>
          </p:cNvPr>
          <p:cNvSpPr txBox="1"/>
          <p:nvPr/>
        </p:nvSpPr>
        <p:spPr>
          <a:xfrm>
            <a:off x="442045" y="138545"/>
            <a:ext cx="485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7183802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D9D7DC3-20D3-3900-E774-95DFF48E8CB7}"/>
              </a:ext>
            </a:extLst>
          </p:cNvPr>
          <p:cNvSpPr txBox="1"/>
          <p:nvPr/>
        </p:nvSpPr>
        <p:spPr>
          <a:xfrm>
            <a:off x="-3716" y="0"/>
            <a:ext cx="12195716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l Figure 3: Week 4 Plasma Cell-Free HPV (</a:t>
            </a:r>
            <a:r>
              <a:rPr lang="en-US" sz="1800" b="1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fHPV</a:t>
            </a:r>
            <a:r>
              <a:rPr lang="en-US" sz="18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or Oral Gargle HPV DNA and its Association with Progression-free Survival (PFS). 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) Comparison of PFS for patients with versus without week 4 plasma </a:t>
            </a:r>
            <a:r>
              <a:rPr lang="en-US" sz="18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fHPV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NA clearance. B) Comparison of PFS for patients with versus without week 4 oral gargle </a:t>
            </a:r>
            <a:r>
              <a:rPr lang="en-US" sz="18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fHPV</a:t>
            </a:r>
            <a:r>
              <a:rPr lang="en-US" sz="18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DNA clearance. Log-rank test represents a comparison between the respective groups. </a:t>
            </a: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4089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</TotalTime>
  <Words>75</Words>
  <Application>Microsoft Macintosh PowerPoint</Application>
  <PresentationFormat>Widescreen</PresentationFormat>
  <Paragraphs>4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bin Park</dc:creator>
  <cp:lastModifiedBy>Robin Park</cp:lastModifiedBy>
  <cp:revision>18</cp:revision>
  <dcterms:created xsi:type="dcterms:W3CDTF">2025-06-06T20:18:21Z</dcterms:created>
  <dcterms:modified xsi:type="dcterms:W3CDTF">2025-07-09T00:33:02Z</dcterms:modified>
</cp:coreProperties>
</file>